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9" r:id="rId2"/>
    <p:sldId id="260" r:id="rId3"/>
    <p:sldId id="261" r:id="rId4"/>
    <p:sldId id="262" r:id="rId5"/>
    <p:sldId id="263" r:id="rId6"/>
    <p:sldId id="264" r:id="rId7"/>
    <p:sldId id="265" r:id="rId8"/>
  </p:sldIdLst>
  <p:sldSz cx="6408738" cy="8280400"/>
  <p:notesSz cx="6669088" cy="9928225"/>
  <p:defaultTextStyle>
    <a:defPPr>
      <a:defRPr lang="de-DE"/>
    </a:defPPr>
    <a:lvl1pPr marL="0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1pPr>
    <a:lvl2pPr marL="340420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2pPr>
    <a:lvl3pPr marL="680841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3pPr>
    <a:lvl4pPr marL="1021261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4pPr>
    <a:lvl5pPr marL="1361681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5pPr>
    <a:lvl6pPr marL="1702102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6pPr>
    <a:lvl7pPr marL="2042522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7pPr>
    <a:lvl8pPr marL="2382943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8pPr>
    <a:lvl9pPr marL="2723363" algn="l" defTabSz="680841" rtl="0" eaLnBrk="1" latinLnBrk="0" hangingPunct="1">
      <a:defRPr sz="134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5" pos="204" userDrawn="1">
          <p15:clr>
            <a:srgbClr val="A4A3A4"/>
          </p15:clr>
        </p15:guide>
        <p15:guide id="55" pos="2019" userDrawn="1">
          <p15:clr>
            <a:srgbClr val="A4A3A4"/>
          </p15:clr>
        </p15:guide>
        <p15:guide id="67" pos="3833" userDrawn="1">
          <p15:clr>
            <a:srgbClr val="A4A3A4"/>
          </p15:clr>
        </p15:guide>
        <p15:guide id="68" orient="horz" pos="26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1044" y="-2898"/>
      </p:cViewPr>
      <p:guideLst>
        <p:guide pos="204"/>
        <p:guide pos="2019"/>
        <p:guide pos="3833"/>
        <p:guide orient="horz" pos="26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0656" y="1355149"/>
            <a:ext cx="5447427" cy="2882806"/>
          </a:xfrm>
        </p:spPr>
        <p:txBody>
          <a:bodyPr anchor="b"/>
          <a:lstStyle>
            <a:lvl1pPr algn="ctr">
              <a:defRPr sz="420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01092" y="4349128"/>
            <a:ext cx="4806554" cy="1999179"/>
          </a:xfrm>
        </p:spPr>
        <p:txBody>
          <a:bodyPr/>
          <a:lstStyle>
            <a:lvl1pPr marL="0" indent="0" algn="ctr">
              <a:buNone/>
              <a:defRPr sz="1682"/>
            </a:lvl1pPr>
            <a:lvl2pPr marL="320451" indent="0" algn="ctr">
              <a:buNone/>
              <a:defRPr sz="1402"/>
            </a:lvl2pPr>
            <a:lvl3pPr marL="640903" indent="0" algn="ctr">
              <a:buNone/>
              <a:defRPr sz="1262"/>
            </a:lvl3pPr>
            <a:lvl4pPr marL="961354" indent="0" algn="ctr">
              <a:buNone/>
              <a:defRPr sz="1121"/>
            </a:lvl4pPr>
            <a:lvl5pPr marL="1281806" indent="0" algn="ctr">
              <a:buNone/>
              <a:defRPr sz="1121"/>
            </a:lvl5pPr>
            <a:lvl6pPr marL="1602257" indent="0" algn="ctr">
              <a:buNone/>
              <a:defRPr sz="1121"/>
            </a:lvl6pPr>
            <a:lvl7pPr marL="1922709" indent="0" algn="ctr">
              <a:buNone/>
              <a:defRPr sz="1121"/>
            </a:lvl7pPr>
            <a:lvl8pPr marL="2243160" indent="0" algn="ctr">
              <a:buNone/>
              <a:defRPr sz="1121"/>
            </a:lvl8pPr>
            <a:lvl9pPr marL="2563612" indent="0" algn="ctr">
              <a:buNone/>
              <a:defRPr sz="1121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30983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4180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86254" y="440855"/>
            <a:ext cx="1381884" cy="70172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0601" y="440855"/>
            <a:ext cx="4065543" cy="70172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438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5925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7263" y="2064352"/>
            <a:ext cx="5527537" cy="3444416"/>
          </a:xfrm>
        </p:spPr>
        <p:txBody>
          <a:bodyPr anchor="b"/>
          <a:lstStyle>
            <a:lvl1pPr>
              <a:defRPr sz="420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7263" y="5541353"/>
            <a:ext cx="5527537" cy="1811337"/>
          </a:xfrm>
        </p:spPr>
        <p:txBody>
          <a:bodyPr/>
          <a:lstStyle>
            <a:lvl1pPr marL="0" indent="0">
              <a:buNone/>
              <a:defRPr sz="1682">
                <a:solidFill>
                  <a:schemeClr val="tx1"/>
                </a:solidFill>
              </a:defRPr>
            </a:lvl1pPr>
            <a:lvl2pPr marL="320451" indent="0">
              <a:buNone/>
              <a:defRPr sz="1402">
                <a:solidFill>
                  <a:schemeClr val="tx1">
                    <a:tint val="75000"/>
                  </a:schemeClr>
                </a:solidFill>
              </a:defRPr>
            </a:lvl2pPr>
            <a:lvl3pPr marL="640903" indent="0">
              <a:buNone/>
              <a:defRPr sz="1262">
                <a:solidFill>
                  <a:schemeClr val="tx1">
                    <a:tint val="75000"/>
                  </a:schemeClr>
                </a:solidFill>
              </a:defRPr>
            </a:lvl3pPr>
            <a:lvl4pPr marL="961354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4pPr>
            <a:lvl5pPr marL="1281806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5pPr>
            <a:lvl6pPr marL="1602257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6pPr>
            <a:lvl7pPr marL="1922709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7pPr>
            <a:lvl8pPr marL="2243160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8pPr>
            <a:lvl9pPr marL="2563612" indent="0">
              <a:buNone/>
              <a:defRPr sz="112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1408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0601" y="2204273"/>
            <a:ext cx="2723714" cy="525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4423" y="2204273"/>
            <a:ext cx="2723714" cy="525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4599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440856"/>
            <a:ext cx="5527537" cy="160049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1436" y="2029849"/>
            <a:ext cx="2711196" cy="994797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436" y="3024646"/>
            <a:ext cx="2711196" cy="444879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44424" y="2029849"/>
            <a:ext cx="2724548" cy="994797"/>
          </a:xfrm>
        </p:spPr>
        <p:txBody>
          <a:bodyPr anchor="b"/>
          <a:lstStyle>
            <a:lvl1pPr marL="0" indent="0">
              <a:buNone/>
              <a:defRPr sz="1682" b="1"/>
            </a:lvl1pPr>
            <a:lvl2pPr marL="320451" indent="0">
              <a:buNone/>
              <a:defRPr sz="1402" b="1"/>
            </a:lvl2pPr>
            <a:lvl3pPr marL="640903" indent="0">
              <a:buNone/>
              <a:defRPr sz="1262" b="1"/>
            </a:lvl3pPr>
            <a:lvl4pPr marL="961354" indent="0">
              <a:buNone/>
              <a:defRPr sz="1121" b="1"/>
            </a:lvl4pPr>
            <a:lvl5pPr marL="1281806" indent="0">
              <a:buNone/>
              <a:defRPr sz="1121" b="1"/>
            </a:lvl5pPr>
            <a:lvl6pPr marL="1602257" indent="0">
              <a:buNone/>
              <a:defRPr sz="1121" b="1"/>
            </a:lvl6pPr>
            <a:lvl7pPr marL="1922709" indent="0">
              <a:buNone/>
              <a:defRPr sz="1121" b="1"/>
            </a:lvl7pPr>
            <a:lvl8pPr marL="2243160" indent="0">
              <a:buNone/>
              <a:defRPr sz="1121" b="1"/>
            </a:lvl8pPr>
            <a:lvl9pPr marL="2563612" indent="0">
              <a:buNone/>
              <a:defRPr sz="1121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44424" y="3024646"/>
            <a:ext cx="2724548" cy="444879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4464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6662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80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52027"/>
            <a:ext cx="2066985" cy="1932093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24548" y="1192226"/>
            <a:ext cx="3244424" cy="5884451"/>
          </a:xfrm>
        </p:spPr>
        <p:txBody>
          <a:bodyPr/>
          <a:lstStyle>
            <a:lvl1pPr>
              <a:defRPr sz="2243"/>
            </a:lvl1pPr>
            <a:lvl2pPr>
              <a:defRPr sz="1963"/>
            </a:lvl2pPr>
            <a:lvl3pPr>
              <a:defRPr sz="1682"/>
            </a:lvl3pPr>
            <a:lvl4pPr>
              <a:defRPr sz="1402"/>
            </a:lvl4pPr>
            <a:lvl5pPr>
              <a:defRPr sz="1402"/>
            </a:lvl5pPr>
            <a:lvl6pPr>
              <a:defRPr sz="1402"/>
            </a:lvl6pPr>
            <a:lvl7pPr>
              <a:defRPr sz="1402"/>
            </a:lvl7pPr>
            <a:lvl8pPr>
              <a:defRPr sz="1402"/>
            </a:lvl8pPr>
            <a:lvl9pPr>
              <a:defRPr sz="1402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484120"/>
            <a:ext cx="2066985" cy="4602140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7715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1435" y="552027"/>
            <a:ext cx="2066985" cy="1932093"/>
          </a:xfrm>
        </p:spPr>
        <p:txBody>
          <a:bodyPr anchor="b"/>
          <a:lstStyle>
            <a:lvl1pPr>
              <a:defRPr sz="224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24548" y="1192226"/>
            <a:ext cx="3244424" cy="5884451"/>
          </a:xfrm>
        </p:spPr>
        <p:txBody>
          <a:bodyPr anchor="t"/>
          <a:lstStyle>
            <a:lvl1pPr marL="0" indent="0">
              <a:buNone/>
              <a:defRPr sz="2243"/>
            </a:lvl1pPr>
            <a:lvl2pPr marL="320451" indent="0">
              <a:buNone/>
              <a:defRPr sz="1963"/>
            </a:lvl2pPr>
            <a:lvl3pPr marL="640903" indent="0">
              <a:buNone/>
              <a:defRPr sz="1682"/>
            </a:lvl3pPr>
            <a:lvl4pPr marL="961354" indent="0">
              <a:buNone/>
              <a:defRPr sz="1402"/>
            </a:lvl4pPr>
            <a:lvl5pPr marL="1281806" indent="0">
              <a:buNone/>
              <a:defRPr sz="1402"/>
            </a:lvl5pPr>
            <a:lvl6pPr marL="1602257" indent="0">
              <a:buNone/>
              <a:defRPr sz="1402"/>
            </a:lvl6pPr>
            <a:lvl7pPr marL="1922709" indent="0">
              <a:buNone/>
              <a:defRPr sz="1402"/>
            </a:lvl7pPr>
            <a:lvl8pPr marL="2243160" indent="0">
              <a:buNone/>
              <a:defRPr sz="1402"/>
            </a:lvl8pPr>
            <a:lvl9pPr marL="2563612" indent="0">
              <a:buNone/>
              <a:defRPr sz="1402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1435" y="2484120"/>
            <a:ext cx="2066985" cy="4602140"/>
          </a:xfrm>
        </p:spPr>
        <p:txBody>
          <a:bodyPr/>
          <a:lstStyle>
            <a:lvl1pPr marL="0" indent="0">
              <a:buNone/>
              <a:defRPr sz="1121"/>
            </a:lvl1pPr>
            <a:lvl2pPr marL="320451" indent="0">
              <a:buNone/>
              <a:defRPr sz="981"/>
            </a:lvl2pPr>
            <a:lvl3pPr marL="640903" indent="0">
              <a:buNone/>
              <a:defRPr sz="841"/>
            </a:lvl3pPr>
            <a:lvl4pPr marL="961354" indent="0">
              <a:buNone/>
              <a:defRPr sz="701"/>
            </a:lvl4pPr>
            <a:lvl5pPr marL="1281806" indent="0">
              <a:buNone/>
              <a:defRPr sz="701"/>
            </a:lvl5pPr>
            <a:lvl6pPr marL="1602257" indent="0">
              <a:buNone/>
              <a:defRPr sz="701"/>
            </a:lvl6pPr>
            <a:lvl7pPr marL="1922709" indent="0">
              <a:buNone/>
              <a:defRPr sz="701"/>
            </a:lvl7pPr>
            <a:lvl8pPr marL="2243160" indent="0">
              <a:buNone/>
              <a:defRPr sz="701"/>
            </a:lvl8pPr>
            <a:lvl9pPr marL="2563612" indent="0">
              <a:buNone/>
              <a:defRPr sz="70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248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0601" y="440856"/>
            <a:ext cx="5527537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0601" y="2204273"/>
            <a:ext cx="5527537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0601" y="7674706"/>
            <a:ext cx="144196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FD123-B170-4916-A323-6CB15E5DF673}" type="datetimeFigureOut">
              <a:rPr lang="de-DE" smtClean="0"/>
              <a:pPr/>
              <a:t>26.05.2017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22895" y="7674706"/>
            <a:ext cx="216294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26171" y="7674706"/>
            <a:ext cx="144196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4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61872E-E124-424A-8A21-2130673FF1B2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152450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40903" rtl="0" eaLnBrk="1" latinLnBrk="0" hangingPunct="1">
        <a:lnSpc>
          <a:spcPct val="90000"/>
        </a:lnSpc>
        <a:spcBef>
          <a:spcPct val="0"/>
        </a:spcBef>
        <a:buNone/>
        <a:defRPr sz="308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0226" indent="-160226" algn="l" defTabSz="640903" rtl="0" eaLnBrk="1" latinLnBrk="0" hangingPunct="1">
        <a:lnSpc>
          <a:spcPct val="90000"/>
        </a:lnSpc>
        <a:spcBef>
          <a:spcPts val="701"/>
        </a:spcBef>
        <a:buFont typeface="Arial" panose="020B0604020202020204" pitchFamily="34" charset="0"/>
        <a:buChar char="•"/>
        <a:defRPr sz="1963" kern="1200">
          <a:solidFill>
            <a:schemeClr val="tx1"/>
          </a:solidFill>
          <a:latin typeface="+mn-lt"/>
          <a:ea typeface="+mn-ea"/>
          <a:cs typeface="+mn-cs"/>
        </a:defRPr>
      </a:lvl1pPr>
      <a:lvl2pPr marL="480677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682" kern="1200">
          <a:solidFill>
            <a:schemeClr val="tx1"/>
          </a:solidFill>
          <a:latin typeface="+mn-lt"/>
          <a:ea typeface="+mn-ea"/>
          <a:cs typeface="+mn-cs"/>
        </a:defRPr>
      </a:lvl2pPr>
      <a:lvl3pPr marL="801129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402" kern="1200">
          <a:solidFill>
            <a:schemeClr val="tx1"/>
          </a:solidFill>
          <a:latin typeface="+mn-lt"/>
          <a:ea typeface="+mn-ea"/>
          <a:cs typeface="+mn-cs"/>
        </a:defRPr>
      </a:lvl3pPr>
      <a:lvl4pPr marL="1121580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442032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762483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2082935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403386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723838" indent="-160226" algn="l" defTabSz="640903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1pPr>
      <a:lvl2pPr marL="320451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2pPr>
      <a:lvl3pPr marL="640903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3pPr>
      <a:lvl4pPr marL="961354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4pPr>
      <a:lvl5pPr marL="1281806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5pPr>
      <a:lvl6pPr marL="1602257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6pPr>
      <a:lvl7pPr marL="1922709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7pPr>
      <a:lvl8pPr marL="2243160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8pPr>
      <a:lvl9pPr marL="2563612" algn="l" defTabSz="640903" rtl="0" eaLnBrk="1" latinLnBrk="0" hangingPunct="1">
        <a:defRPr sz="12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4.tiff"/><Relationship Id="rId26" Type="http://schemas.openxmlformats.org/officeDocument/2006/relationships/oleObject" Target="../embeddings/oleObject10.bin"/><Relationship Id="rId3" Type="http://schemas.openxmlformats.org/officeDocument/2006/relationships/oleObject" Target="../embeddings/oleObject1.bin"/><Relationship Id="rId21" Type="http://schemas.openxmlformats.org/officeDocument/2006/relationships/image" Target="../media/image7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13.jpeg"/><Relationship Id="rId25" Type="http://schemas.openxmlformats.org/officeDocument/2006/relationships/image" Target="../media/image9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2.jpeg"/><Relationship Id="rId20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oleObject" Target="../embeddings/oleObject9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1.jpeg"/><Relationship Id="rId23" Type="http://schemas.openxmlformats.org/officeDocument/2006/relationships/image" Target="../media/image8.emf"/><Relationship Id="rId10" Type="http://schemas.openxmlformats.org/officeDocument/2006/relationships/image" Target="../media/image4.emf"/><Relationship Id="rId19" Type="http://schemas.openxmlformats.org/officeDocument/2006/relationships/image" Target="../media/image15.tif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oleObject" Target="../embeddings/oleObject8.bin"/><Relationship Id="rId27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13" Type="http://schemas.openxmlformats.org/officeDocument/2006/relationships/image" Target="../media/image30.tiff"/><Relationship Id="rId18" Type="http://schemas.openxmlformats.org/officeDocument/2006/relationships/image" Target="../media/image35.tiff"/><Relationship Id="rId3" Type="http://schemas.openxmlformats.org/officeDocument/2006/relationships/image" Target="../media/image20.jpeg"/><Relationship Id="rId21" Type="http://schemas.openxmlformats.org/officeDocument/2006/relationships/image" Target="../media/image38.tiff"/><Relationship Id="rId7" Type="http://schemas.openxmlformats.org/officeDocument/2006/relationships/image" Target="../media/image24.jpeg"/><Relationship Id="rId12" Type="http://schemas.openxmlformats.org/officeDocument/2006/relationships/image" Target="../media/image29.tiff"/><Relationship Id="rId17" Type="http://schemas.openxmlformats.org/officeDocument/2006/relationships/image" Target="../media/image34.tiff"/><Relationship Id="rId2" Type="http://schemas.openxmlformats.org/officeDocument/2006/relationships/image" Target="../media/image19.jpeg"/><Relationship Id="rId16" Type="http://schemas.openxmlformats.org/officeDocument/2006/relationships/image" Target="../media/image33.tiff"/><Relationship Id="rId20" Type="http://schemas.openxmlformats.org/officeDocument/2006/relationships/image" Target="../media/image37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jpeg"/><Relationship Id="rId11" Type="http://schemas.openxmlformats.org/officeDocument/2006/relationships/image" Target="../media/image28.tiff"/><Relationship Id="rId24" Type="http://schemas.openxmlformats.org/officeDocument/2006/relationships/image" Target="../media/image41.tif"/><Relationship Id="rId5" Type="http://schemas.openxmlformats.org/officeDocument/2006/relationships/image" Target="../media/image22.jpeg"/><Relationship Id="rId15" Type="http://schemas.openxmlformats.org/officeDocument/2006/relationships/image" Target="../media/image32.tiff"/><Relationship Id="rId23" Type="http://schemas.openxmlformats.org/officeDocument/2006/relationships/image" Target="../media/image40.tiff"/><Relationship Id="rId10" Type="http://schemas.openxmlformats.org/officeDocument/2006/relationships/image" Target="../media/image27.jpeg"/><Relationship Id="rId19" Type="http://schemas.openxmlformats.org/officeDocument/2006/relationships/image" Target="../media/image36.tiff"/><Relationship Id="rId4" Type="http://schemas.openxmlformats.org/officeDocument/2006/relationships/image" Target="../media/image21.jpeg"/><Relationship Id="rId9" Type="http://schemas.openxmlformats.org/officeDocument/2006/relationships/image" Target="../media/image26.jpeg"/><Relationship Id="rId14" Type="http://schemas.openxmlformats.org/officeDocument/2006/relationships/image" Target="../media/image31.tiff"/><Relationship Id="rId22" Type="http://schemas.openxmlformats.org/officeDocument/2006/relationships/image" Target="../media/image3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f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5.tiff"/><Relationship Id="rId4" Type="http://schemas.openxmlformats.org/officeDocument/2006/relationships/image" Target="../media/image44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TextBox 148"/>
          <p:cNvSpPr txBox="1"/>
          <p:nvPr/>
        </p:nvSpPr>
        <p:spPr>
          <a:xfrm>
            <a:off x="198283" y="333755"/>
            <a:ext cx="261610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/>
              <a:t>A</a:t>
            </a:r>
          </a:p>
        </p:txBody>
      </p:sp>
      <p:graphicFrame>
        <p:nvGraphicFramePr>
          <p:cNvPr id="150" name="Object 14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2315582"/>
              </p:ext>
            </p:extLst>
          </p:nvPr>
        </p:nvGraphicFramePr>
        <p:xfrm>
          <a:off x="184679" y="1887162"/>
          <a:ext cx="1618519" cy="13700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4" name="Prism 6" r:id="rId3" imgW="1954457" imgH="1654188" progId="Prism6.Document">
                  <p:embed/>
                </p:oleObj>
              </mc:Choice>
              <mc:Fallback>
                <p:oleObj name="Prism 6" r:id="rId3" imgW="1954457" imgH="1654188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4679" y="1887162"/>
                        <a:ext cx="1618519" cy="137002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1" name="Object 15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3307499"/>
              </p:ext>
            </p:extLst>
          </p:nvPr>
        </p:nvGraphicFramePr>
        <p:xfrm>
          <a:off x="1728520" y="1881066"/>
          <a:ext cx="1618519" cy="13700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5" name="Prism 6" r:id="rId5" imgW="1954457" imgH="1654188" progId="Prism6.Document">
                  <p:embed/>
                </p:oleObj>
              </mc:Choice>
              <mc:Fallback>
                <p:oleObj name="Prism 6" r:id="rId5" imgW="1954457" imgH="1654188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28520" y="1881066"/>
                        <a:ext cx="1618519" cy="137002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2" name="Object 15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8449604"/>
              </p:ext>
            </p:extLst>
          </p:nvPr>
        </p:nvGraphicFramePr>
        <p:xfrm>
          <a:off x="4585136" y="3257213"/>
          <a:ext cx="1656649" cy="1514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6" name="Prism 6" r:id="rId7" imgW="2000194" imgH="1828142" progId="Prism6.Document">
                  <p:embed/>
                </p:oleObj>
              </mc:Choice>
              <mc:Fallback>
                <p:oleObj name="Prism 6" r:id="rId7" imgW="2000194" imgH="1828142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85136" y="3257213"/>
                        <a:ext cx="1656649" cy="1514651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" name="Object 15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93817847"/>
              </p:ext>
            </p:extLst>
          </p:nvPr>
        </p:nvGraphicFramePr>
        <p:xfrm>
          <a:off x="190333" y="4914129"/>
          <a:ext cx="1697407" cy="13700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7" name="Prism 6" r:id="rId9" imgW="2049172" imgH="1654188" progId="Prism6.Document">
                  <p:embed/>
                </p:oleObj>
              </mc:Choice>
              <mc:Fallback>
                <p:oleObj name="Prism 6" r:id="rId9" imgW="2049172" imgH="1654188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0333" y="4914129"/>
                        <a:ext cx="1697407" cy="1370023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4" name="Object 15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811640"/>
              </p:ext>
            </p:extLst>
          </p:nvPr>
        </p:nvGraphicFramePr>
        <p:xfrm>
          <a:off x="1953788" y="5094140"/>
          <a:ext cx="1860443" cy="13752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58" name="Prism 6" r:id="rId11" imgW="2245806" imgH="1660310" progId="Prism6.Document">
                  <p:embed/>
                </p:oleObj>
              </mc:Choice>
              <mc:Fallback>
                <p:oleObj name="Prism 6" r:id="rId11" imgW="2245806" imgH="1660310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53788" y="5094140"/>
                        <a:ext cx="1860443" cy="1375281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55" name="Group 154"/>
          <p:cNvGrpSpPr/>
          <p:nvPr/>
        </p:nvGrpSpPr>
        <p:grpSpPr>
          <a:xfrm>
            <a:off x="3798245" y="5009037"/>
            <a:ext cx="1967996" cy="1454980"/>
            <a:chOff x="247522" y="4734164"/>
            <a:chExt cx="2376172" cy="1756754"/>
          </a:xfrm>
        </p:grpSpPr>
        <p:graphicFrame>
          <p:nvGraphicFramePr>
            <p:cNvPr id="156" name="Object 155"/>
            <p:cNvGraphicFramePr>
              <a:graphicFrameLocks noChangeAspect="1"/>
            </p:cNvGraphicFramePr>
            <p:nvPr>
              <p:extLst/>
            </p:nvPr>
          </p:nvGraphicFramePr>
          <p:xfrm>
            <a:off x="247522" y="4830393"/>
            <a:ext cx="2246312" cy="1660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59" name="Prism 6" r:id="rId13" imgW="2245806" imgH="1660310" progId="Prism6.Document">
                    <p:embed/>
                  </p:oleObj>
                </mc:Choice>
                <mc:Fallback>
                  <p:oleObj name="Prism 6" r:id="rId13" imgW="2245806" imgH="1660310" progId="Prism6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7522" y="4830393"/>
                          <a:ext cx="2246312" cy="166052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57" name="Picture 156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2783" y="4972475"/>
              <a:ext cx="1224000" cy="205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58" name="Picture 157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2783" y="4734164"/>
              <a:ext cx="1224000" cy="205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59" name="Textfeld 19"/>
            <p:cNvSpPr txBox="1">
              <a:spLocks noChangeArrowheads="1"/>
            </p:cNvSpPr>
            <p:nvPr/>
          </p:nvSpPr>
          <p:spPr bwMode="auto">
            <a:xfrm>
              <a:off x="2092986" y="4740011"/>
              <a:ext cx="530708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TIF-IA</a:t>
              </a:r>
            </a:p>
          </p:txBody>
        </p:sp>
        <p:sp>
          <p:nvSpPr>
            <p:cNvPr id="160" name="Textfeld 27"/>
            <p:cNvSpPr txBox="1">
              <a:spLocks noChangeArrowheads="1"/>
            </p:cNvSpPr>
            <p:nvPr/>
          </p:nvSpPr>
          <p:spPr bwMode="auto">
            <a:xfrm>
              <a:off x="2092986" y="4981613"/>
              <a:ext cx="530708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β-Actin</a:t>
              </a:r>
            </a:p>
          </p:txBody>
        </p:sp>
      </p:grpSp>
      <p:sp>
        <p:nvSpPr>
          <p:cNvPr id="161" name="TextBox 160"/>
          <p:cNvSpPr txBox="1"/>
          <p:nvPr/>
        </p:nvSpPr>
        <p:spPr>
          <a:xfrm>
            <a:off x="198283" y="1651473"/>
            <a:ext cx="256802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/>
              <a:t>B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2001658" y="3213994"/>
            <a:ext cx="264816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/>
              <a:t>D</a:t>
            </a:r>
          </a:p>
        </p:txBody>
      </p:sp>
      <p:sp>
        <p:nvSpPr>
          <p:cNvPr id="163" name="TextBox 162"/>
          <p:cNvSpPr txBox="1"/>
          <p:nvPr/>
        </p:nvSpPr>
        <p:spPr>
          <a:xfrm>
            <a:off x="190333" y="3183514"/>
            <a:ext cx="251992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/>
              <a:t>C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211262" y="4838281"/>
            <a:ext cx="243978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/>
              <a:t>F</a:t>
            </a:r>
          </a:p>
        </p:txBody>
      </p:sp>
      <p:sp>
        <p:nvSpPr>
          <p:cNvPr id="165" name="TextBox 164"/>
          <p:cNvSpPr txBox="1"/>
          <p:nvPr/>
        </p:nvSpPr>
        <p:spPr>
          <a:xfrm>
            <a:off x="4592611" y="3181367"/>
            <a:ext cx="247184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/>
              <a:t>E</a:t>
            </a:r>
          </a:p>
        </p:txBody>
      </p:sp>
      <p:sp>
        <p:nvSpPr>
          <p:cNvPr id="166" name="TextBox 165"/>
          <p:cNvSpPr txBox="1"/>
          <p:nvPr/>
        </p:nvSpPr>
        <p:spPr>
          <a:xfrm>
            <a:off x="1965861" y="4839418"/>
            <a:ext cx="266420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/>
              <a:t>G</a:t>
            </a:r>
          </a:p>
        </p:txBody>
      </p:sp>
      <p:grpSp>
        <p:nvGrpSpPr>
          <p:cNvPr id="167" name="Group 166"/>
          <p:cNvGrpSpPr/>
          <p:nvPr/>
        </p:nvGrpSpPr>
        <p:grpSpPr>
          <a:xfrm>
            <a:off x="2317250" y="3439011"/>
            <a:ext cx="2418859" cy="930053"/>
            <a:chOff x="784161" y="6028513"/>
            <a:chExt cx="2920548" cy="1122953"/>
          </a:xfrm>
        </p:grpSpPr>
        <p:grpSp>
          <p:nvGrpSpPr>
            <p:cNvPr id="168" name="Group 167"/>
            <p:cNvGrpSpPr/>
            <p:nvPr/>
          </p:nvGrpSpPr>
          <p:grpSpPr>
            <a:xfrm>
              <a:off x="2264423" y="6453943"/>
              <a:ext cx="1440286" cy="697523"/>
              <a:chOff x="2041146" y="5805375"/>
              <a:chExt cx="1440286" cy="697523"/>
            </a:xfrm>
          </p:grpSpPr>
          <p:sp>
            <p:nvSpPr>
              <p:cNvPr id="178" name="Textfeld 19"/>
              <p:cNvSpPr txBox="1">
                <a:spLocks noChangeArrowheads="1"/>
              </p:cNvSpPr>
              <p:nvPr/>
            </p:nvSpPr>
            <p:spPr bwMode="auto">
              <a:xfrm>
                <a:off x="2164920" y="5805375"/>
                <a:ext cx="705150" cy="2192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defPPr>
                  <a:defRPr lang="de-DE"/>
                </a:defPPr>
                <a:lvl1pPr marL="0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340420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68084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02126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36168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702102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042522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2382943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2723363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lnSpc>
                    <a:spcPct val="100000"/>
                  </a:lnSpc>
                  <a:spcBef>
                    <a:spcPct val="0"/>
                  </a:spcBef>
                  <a:buFontTx/>
                  <a:buNone/>
                </a:pPr>
                <a:r>
                  <a:rPr lang="de-DE" altLang="de-DE" sz="58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7S rRNA</a:t>
                </a:r>
              </a:p>
            </p:txBody>
          </p:sp>
          <p:sp>
            <p:nvSpPr>
              <p:cNvPr id="179" name="Textfeld 27"/>
              <p:cNvSpPr txBox="1">
                <a:spLocks noChangeArrowheads="1"/>
              </p:cNvSpPr>
              <p:nvPr/>
            </p:nvSpPr>
            <p:spPr bwMode="auto">
              <a:xfrm>
                <a:off x="2164920" y="6142673"/>
                <a:ext cx="1316512" cy="2192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de-DE"/>
                </a:defPPr>
                <a:lvl1pPr marL="0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340420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68084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02126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36168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702102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042522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2382943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2723363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>
                  <a:lnSpc>
                    <a:spcPct val="100000"/>
                  </a:lnSpc>
                  <a:spcBef>
                    <a:spcPct val="0"/>
                  </a:spcBef>
                  <a:buNone/>
                </a:pPr>
                <a:r>
                  <a:rPr lang="de-DE" altLang="de-DE" sz="58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bortive rRNA transcripts</a:t>
                </a:r>
              </a:p>
            </p:txBody>
          </p:sp>
          <p:sp>
            <p:nvSpPr>
              <p:cNvPr id="180" name="Right Brace 179"/>
              <p:cNvSpPr/>
              <p:nvPr/>
            </p:nvSpPr>
            <p:spPr>
              <a:xfrm>
                <a:off x="2041146" y="5962898"/>
                <a:ext cx="108000" cy="540000"/>
              </a:xfrm>
              <a:prstGeom prst="rightBrace">
                <a:avLst/>
              </a:prstGeom>
              <a:noFill/>
              <a:ln w="158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>
                <a:defPPr>
                  <a:defRPr lang="de-DE"/>
                </a:defPPr>
                <a:lvl1pPr marL="0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340420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68084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02126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361681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1702102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042522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2382943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2723363" algn="l" defTabSz="680841" rtl="0" eaLnBrk="1" latinLnBrk="0" hangingPunct="1">
                  <a:defRPr sz="134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de-DE" sz="1109"/>
              </a:p>
            </p:txBody>
          </p:sp>
          <p:cxnSp>
            <p:nvCxnSpPr>
              <p:cNvPr id="181" name="Straight Arrow Connector 180"/>
              <p:cNvCxnSpPr/>
              <p:nvPr/>
            </p:nvCxnSpPr>
            <p:spPr>
              <a:xfrm>
                <a:off x="2087685" y="5894769"/>
                <a:ext cx="67326" cy="1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69" name="Textfeld 35"/>
            <p:cNvSpPr txBox="1">
              <a:spLocks noChangeArrowheads="1"/>
            </p:cNvSpPr>
            <p:nvPr/>
          </p:nvSpPr>
          <p:spPr bwMode="auto">
            <a:xfrm rot="16200000">
              <a:off x="623594" y="6189080"/>
              <a:ext cx="540385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70" name="Textfeld 36"/>
            <p:cNvSpPr txBox="1">
              <a:spLocks noChangeArrowheads="1"/>
            </p:cNvSpPr>
            <p:nvPr/>
          </p:nvSpPr>
          <p:spPr bwMode="auto">
            <a:xfrm rot="16200000">
              <a:off x="885066" y="6296483"/>
              <a:ext cx="327483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171" name="Textfeld 37"/>
            <p:cNvSpPr txBox="1">
              <a:spLocks noChangeArrowheads="1"/>
            </p:cNvSpPr>
            <p:nvPr/>
          </p:nvSpPr>
          <p:spPr bwMode="auto">
            <a:xfrm rot="16200000">
              <a:off x="1002343" y="6258812"/>
              <a:ext cx="402967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0.5h</a:t>
              </a:r>
            </a:p>
          </p:txBody>
        </p:sp>
        <p:sp>
          <p:nvSpPr>
            <p:cNvPr id="172" name="Textfeld 38"/>
            <p:cNvSpPr txBox="1">
              <a:spLocks noChangeArrowheads="1"/>
            </p:cNvSpPr>
            <p:nvPr/>
          </p:nvSpPr>
          <p:spPr bwMode="auto">
            <a:xfrm rot="16200000">
              <a:off x="1350122" y="6296483"/>
              <a:ext cx="327483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1h</a:t>
              </a:r>
            </a:p>
          </p:txBody>
        </p:sp>
        <p:sp>
          <p:nvSpPr>
            <p:cNvPr id="173" name="Textfeld 39"/>
            <p:cNvSpPr txBox="1">
              <a:spLocks noChangeArrowheads="1"/>
            </p:cNvSpPr>
            <p:nvPr/>
          </p:nvSpPr>
          <p:spPr bwMode="auto">
            <a:xfrm rot="16200000">
              <a:off x="1505141" y="6296483"/>
              <a:ext cx="327483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3h</a:t>
              </a:r>
            </a:p>
          </p:txBody>
        </p:sp>
        <p:sp>
          <p:nvSpPr>
            <p:cNvPr id="174" name="Textfeld 40"/>
            <p:cNvSpPr txBox="1">
              <a:spLocks noChangeArrowheads="1"/>
            </p:cNvSpPr>
            <p:nvPr/>
          </p:nvSpPr>
          <p:spPr bwMode="auto">
            <a:xfrm rot="16200000">
              <a:off x="1660160" y="6296483"/>
              <a:ext cx="327483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6h</a:t>
              </a:r>
            </a:p>
          </p:txBody>
        </p:sp>
        <p:sp>
          <p:nvSpPr>
            <p:cNvPr id="175" name="Textfeld 41"/>
            <p:cNvSpPr txBox="1">
              <a:spLocks noChangeArrowheads="1"/>
            </p:cNvSpPr>
            <p:nvPr/>
          </p:nvSpPr>
          <p:spPr bwMode="auto">
            <a:xfrm rot="16200000">
              <a:off x="1790018" y="6271635"/>
              <a:ext cx="377805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12h</a:t>
              </a:r>
            </a:p>
          </p:txBody>
        </p:sp>
        <p:sp>
          <p:nvSpPr>
            <p:cNvPr id="176" name="Textfeld 42"/>
            <p:cNvSpPr txBox="1">
              <a:spLocks noChangeArrowheads="1"/>
            </p:cNvSpPr>
            <p:nvPr/>
          </p:nvSpPr>
          <p:spPr bwMode="auto">
            <a:xfrm rot="16200000">
              <a:off x="1945035" y="6271635"/>
              <a:ext cx="377805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177" name="Textfeld 37"/>
            <p:cNvSpPr txBox="1">
              <a:spLocks noChangeArrowheads="1"/>
            </p:cNvSpPr>
            <p:nvPr/>
          </p:nvSpPr>
          <p:spPr bwMode="auto">
            <a:xfrm rot="16200000">
              <a:off x="1132201" y="6233962"/>
              <a:ext cx="453290" cy="2192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de-DE"/>
              </a:defPPr>
              <a:lvl1pPr marL="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340420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68084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02126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361681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70210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042522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238294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723363" algn="l" defTabSz="680841" rtl="0" eaLnBrk="1" latinLnBrk="0" hangingPunct="1">
                <a:defRPr sz="134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580" b="1" dirty="0">
                  <a:latin typeface="Arial" panose="020B0604020202020204" pitchFamily="34" charset="0"/>
                  <a:cs typeface="Arial" panose="020B0604020202020204" pitchFamily="34" charset="0"/>
                </a:rPr>
                <a:t>0.75h</a:t>
              </a:r>
            </a:p>
          </p:txBody>
        </p:sp>
      </p:grpSp>
      <p:pic>
        <p:nvPicPr>
          <p:cNvPr id="183" name="Picture 88" descr="F:\11 09.26.jpg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2358982" y="3821065"/>
            <a:ext cx="1128183" cy="59560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184" name="Picture 183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4014" y="2268939"/>
            <a:ext cx="1441285" cy="2353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5" name="Picture 184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4014" y="2544746"/>
            <a:ext cx="1441285" cy="1962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6" name="TextBox 185"/>
          <p:cNvSpPr txBox="1"/>
          <p:nvPr/>
        </p:nvSpPr>
        <p:spPr>
          <a:xfrm rot="19097734">
            <a:off x="3702054" y="2033703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 rot="19097734">
            <a:off x="3903953" y="2095741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 h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 rot="19097734">
            <a:off x="4087905" y="2103043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h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 rot="19097734">
            <a:off x="4285012" y="2087278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 h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 rot="19097734">
            <a:off x="4473268" y="2102816"/>
            <a:ext cx="2760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 h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 rot="19097734">
            <a:off x="4668887" y="2087575"/>
            <a:ext cx="31130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 h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 rot="19097734">
            <a:off x="4881049" y="2079964"/>
            <a:ext cx="31130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3387667" y="2252711"/>
            <a:ext cx="383438" cy="1692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PL13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3388847" y="2352738"/>
            <a:ext cx="383438" cy="169277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PL11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feld 19"/>
          <p:cNvSpPr txBox="1">
            <a:spLocks noChangeArrowheads="1"/>
          </p:cNvSpPr>
          <p:nvPr/>
        </p:nvSpPr>
        <p:spPr bwMode="auto">
          <a:xfrm>
            <a:off x="3385678" y="2550671"/>
            <a:ext cx="485087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5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5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graphicFrame>
        <p:nvGraphicFramePr>
          <p:cNvPr id="199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7996139"/>
              </p:ext>
            </p:extLst>
          </p:nvPr>
        </p:nvGraphicFramePr>
        <p:xfrm>
          <a:off x="355600" y="3386453"/>
          <a:ext cx="1762125" cy="1365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60" name="Prism 6" r:id="rId20" imgW="3622245" imgH="2807041" progId="Prism6.Document">
                  <p:embed/>
                </p:oleObj>
              </mc:Choice>
              <mc:Fallback>
                <p:oleObj name="Prism 6" r:id="rId20" imgW="3622245" imgH="2807041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5600" y="3386453"/>
                        <a:ext cx="1762125" cy="13652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0" name="TextBox 199"/>
          <p:cNvSpPr txBox="1"/>
          <p:nvPr/>
        </p:nvSpPr>
        <p:spPr>
          <a:xfrm>
            <a:off x="3632854" y="4838281"/>
            <a:ext cx="266420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 smtClean="0"/>
              <a:t>H</a:t>
            </a:r>
            <a:endParaRPr lang="de-DE" sz="995" b="1" dirty="0"/>
          </a:p>
        </p:txBody>
      </p:sp>
      <p:sp>
        <p:nvSpPr>
          <p:cNvPr id="51" name="Rectangle 50"/>
          <p:cNvSpPr/>
          <p:nvPr/>
        </p:nvSpPr>
        <p:spPr>
          <a:xfrm>
            <a:off x="143192" y="-7580"/>
            <a:ext cx="89864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igure S1</a:t>
            </a:r>
            <a:endParaRPr lang="de-DE" sz="1500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3817886"/>
              </p:ext>
            </p:extLst>
          </p:nvPr>
        </p:nvGraphicFramePr>
        <p:xfrm>
          <a:off x="2119826" y="6728819"/>
          <a:ext cx="1271588" cy="1428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61" name="Prism 6" r:id="rId22" imgW="2506545" imgH="2817485" progId="Prism6.Document">
                  <p:embed/>
                </p:oleObj>
              </mc:Choice>
              <mc:Fallback>
                <p:oleObj name="Prism 6" r:id="rId22" imgW="2506545" imgH="281748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119826" y="6728819"/>
                        <a:ext cx="1271588" cy="1428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" name="TextBox 51"/>
          <p:cNvSpPr txBox="1"/>
          <p:nvPr/>
        </p:nvSpPr>
        <p:spPr>
          <a:xfrm>
            <a:off x="2000054" y="6554388"/>
            <a:ext cx="226344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 smtClean="0"/>
              <a:t>J</a:t>
            </a:r>
            <a:endParaRPr lang="de-DE" sz="995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200041" y="6553335"/>
            <a:ext cx="218330" cy="2454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95" b="1" dirty="0" smtClean="0"/>
              <a:t>I</a:t>
            </a:r>
            <a:endParaRPr lang="de-DE" sz="995" b="1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9103406"/>
              </p:ext>
            </p:extLst>
          </p:nvPr>
        </p:nvGraphicFramePr>
        <p:xfrm>
          <a:off x="461589" y="6798787"/>
          <a:ext cx="1187171" cy="13345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62" name="Prism 6" r:id="rId24" imgW="2506545" imgH="2817485" progId="Prism6.Document">
                  <p:embed/>
                </p:oleObj>
              </mc:Choice>
              <mc:Fallback>
                <p:oleObj name="Prism 6" r:id="rId24" imgW="2506545" imgH="281748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461589" y="6798787"/>
                        <a:ext cx="1187171" cy="13345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5" name="Objec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9045680"/>
              </p:ext>
            </p:extLst>
          </p:nvPr>
        </p:nvGraphicFramePr>
        <p:xfrm>
          <a:off x="273050" y="519113"/>
          <a:ext cx="1836738" cy="1365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63" name="Prism 6" r:id="rId26" imgW="3686349" imgH="2736811" progId="Prism6.Document">
                  <p:embed/>
                </p:oleObj>
              </mc:Choice>
              <mc:Fallback>
                <p:oleObj name="Prism 6" r:id="rId26" imgW="3686349" imgH="273681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273050" y="519113"/>
                        <a:ext cx="1836738" cy="1365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884009" y="6862658"/>
            <a:ext cx="2247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049995" y="7048472"/>
            <a:ext cx="3786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0931</a:t>
            </a:r>
            <a:endParaRPr lang="de-DE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9038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/>
          <p:cNvSpPr txBox="1"/>
          <p:nvPr/>
        </p:nvSpPr>
        <p:spPr>
          <a:xfrm>
            <a:off x="0" y="339816"/>
            <a:ext cx="29527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/>
              <a:t>A</a:t>
            </a:r>
            <a:endParaRPr lang="de-DE" sz="1500" dirty="0"/>
          </a:p>
        </p:txBody>
      </p:sp>
      <p:sp>
        <p:nvSpPr>
          <p:cNvPr id="52" name="TextBox 51"/>
          <p:cNvSpPr txBox="1"/>
          <p:nvPr/>
        </p:nvSpPr>
        <p:spPr>
          <a:xfrm>
            <a:off x="-1386" y="2455360"/>
            <a:ext cx="28725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/>
              <a:t>C</a:t>
            </a:r>
          </a:p>
        </p:txBody>
      </p:sp>
      <p:grpSp>
        <p:nvGrpSpPr>
          <p:cNvPr id="53" name="Group 52"/>
          <p:cNvGrpSpPr/>
          <p:nvPr/>
        </p:nvGrpSpPr>
        <p:grpSpPr>
          <a:xfrm>
            <a:off x="462442" y="2648331"/>
            <a:ext cx="1719620" cy="1744111"/>
            <a:chOff x="637956" y="4792541"/>
            <a:chExt cx="1719620" cy="1744111"/>
          </a:xfrm>
        </p:grpSpPr>
        <p:sp>
          <p:nvSpPr>
            <p:cNvPr id="54" name="Textfeld 31"/>
            <p:cNvSpPr txBox="1">
              <a:spLocks noChangeArrowheads="1"/>
            </p:cNvSpPr>
            <p:nvPr/>
          </p:nvSpPr>
          <p:spPr bwMode="auto">
            <a:xfrm>
              <a:off x="773550" y="5559035"/>
              <a:ext cx="345156" cy="2027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p53</a:t>
              </a:r>
            </a:p>
          </p:txBody>
        </p:sp>
        <p:sp>
          <p:nvSpPr>
            <p:cNvPr id="55" name="Textfeld 32"/>
            <p:cNvSpPr txBox="1">
              <a:spLocks noChangeArrowheads="1"/>
            </p:cNvSpPr>
            <p:nvPr/>
          </p:nvSpPr>
          <p:spPr bwMode="auto">
            <a:xfrm>
              <a:off x="637956" y="6332324"/>
              <a:ext cx="484489" cy="2043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el-GR" altLang="de-DE" sz="700" b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β</a:t>
              </a:r>
              <a:r>
                <a:rPr lang="de-DE" altLang="de-DE" sz="700" b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-actin</a:t>
              </a:r>
            </a:p>
          </p:txBody>
        </p:sp>
        <p:sp>
          <p:nvSpPr>
            <p:cNvPr id="56" name="Textfeld 35"/>
            <p:cNvSpPr txBox="1">
              <a:spLocks noChangeArrowheads="1"/>
            </p:cNvSpPr>
            <p:nvPr/>
          </p:nvSpPr>
          <p:spPr bwMode="auto">
            <a:xfrm rot="16200000">
              <a:off x="896223" y="4944345"/>
              <a:ext cx="50366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57" name="Textfeld 36"/>
            <p:cNvSpPr txBox="1">
              <a:spLocks noChangeArrowheads="1"/>
            </p:cNvSpPr>
            <p:nvPr/>
          </p:nvSpPr>
          <p:spPr bwMode="auto">
            <a:xfrm rot="16200000">
              <a:off x="1106388" y="5051747"/>
              <a:ext cx="288861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h</a:t>
              </a:r>
            </a:p>
          </p:txBody>
        </p:sp>
        <p:sp>
          <p:nvSpPr>
            <p:cNvPr id="58" name="Textfeld 37"/>
            <p:cNvSpPr txBox="1">
              <a:spLocks noChangeArrowheads="1"/>
            </p:cNvSpPr>
            <p:nvPr/>
          </p:nvSpPr>
          <p:spPr bwMode="auto">
            <a:xfrm rot="16200000">
              <a:off x="1175336" y="5014076"/>
              <a:ext cx="364202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0.5h</a:t>
              </a:r>
            </a:p>
          </p:txBody>
        </p:sp>
        <p:sp>
          <p:nvSpPr>
            <p:cNvPr id="59" name="Textfeld 38"/>
            <p:cNvSpPr txBox="1">
              <a:spLocks noChangeArrowheads="1"/>
            </p:cNvSpPr>
            <p:nvPr/>
          </p:nvSpPr>
          <p:spPr bwMode="auto">
            <a:xfrm rot="16200000">
              <a:off x="1308240" y="5051747"/>
              <a:ext cx="288861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h</a:t>
              </a:r>
            </a:p>
          </p:txBody>
        </p:sp>
        <p:sp>
          <p:nvSpPr>
            <p:cNvPr id="60" name="Textfeld 39"/>
            <p:cNvSpPr txBox="1">
              <a:spLocks noChangeArrowheads="1"/>
            </p:cNvSpPr>
            <p:nvPr/>
          </p:nvSpPr>
          <p:spPr bwMode="auto">
            <a:xfrm rot="16200000">
              <a:off x="1411204" y="5051747"/>
              <a:ext cx="288861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h</a:t>
              </a:r>
            </a:p>
          </p:txBody>
        </p:sp>
        <p:sp>
          <p:nvSpPr>
            <p:cNvPr id="61" name="Textfeld 40"/>
            <p:cNvSpPr txBox="1">
              <a:spLocks noChangeArrowheads="1"/>
            </p:cNvSpPr>
            <p:nvPr/>
          </p:nvSpPr>
          <p:spPr bwMode="auto">
            <a:xfrm rot="16200000">
              <a:off x="1507812" y="5051747"/>
              <a:ext cx="288861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h</a:t>
              </a:r>
            </a:p>
          </p:txBody>
        </p:sp>
        <p:sp>
          <p:nvSpPr>
            <p:cNvPr id="62" name="Textfeld 41"/>
            <p:cNvSpPr txBox="1">
              <a:spLocks noChangeArrowheads="1"/>
            </p:cNvSpPr>
            <p:nvPr/>
          </p:nvSpPr>
          <p:spPr bwMode="auto">
            <a:xfrm rot="16200000">
              <a:off x="1591768" y="5026900"/>
              <a:ext cx="33855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12h</a:t>
              </a:r>
            </a:p>
          </p:txBody>
        </p:sp>
        <p:sp>
          <p:nvSpPr>
            <p:cNvPr id="63" name="Textfeld 42"/>
            <p:cNvSpPr txBox="1">
              <a:spLocks noChangeArrowheads="1"/>
            </p:cNvSpPr>
            <p:nvPr/>
          </p:nvSpPr>
          <p:spPr bwMode="auto">
            <a:xfrm rot="16200000">
              <a:off x="1688555" y="5026900"/>
              <a:ext cx="33855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24h</a:t>
              </a:r>
            </a:p>
          </p:txBody>
        </p:sp>
        <p:sp>
          <p:nvSpPr>
            <p:cNvPr id="64" name="Textfeld 43"/>
            <p:cNvSpPr txBox="1">
              <a:spLocks noChangeArrowheads="1"/>
            </p:cNvSpPr>
            <p:nvPr/>
          </p:nvSpPr>
          <p:spPr bwMode="auto">
            <a:xfrm rot="16200000">
              <a:off x="1791428" y="5026900"/>
              <a:ext cx="33855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36h</a:t>
              </a:r>
            </a:p>
          </p:txBody>
        </p:sp>
        <p:sp>
          <p:nvSpPr>
            <p:cNvPr id="65" name="Textfeld 44"/>
            <p:cNvSpPr txBox="1">
              <a:spLocks noChangeArrowheads="1"/>
            </p:cNvSpPr>
            <p:nvPr/>
          </p:nvSpPr>
          <p:spPr bwMode="auto">
            <a:xfrm rot="16200000">
              <a:off x="1887420" y="5026900"/>
              <a:ext cx="33855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48h</a:t>
              </a:r>
            </a:p>
          </p:txBody>
        </p:sp>
        <p:sp>
          <p:nvSpPr>
            <p:cNvPr id="66" name="Textfeld 45"/>
            <p:cNvSpPr txBox="1">
              <a:spLocks noChangeArrowheads="1"/>
            </p:cNvSpPr>
            <p:nvPr/>
          </p:nvSpPr>
          <p:spPr bwMode="auto">
            <a:xfrm rot="16200000">
              <a:off x="1981634" y="5026900"/>
              <a:ext cx="33855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60h</a:t>
              </a:r>
            </a:p>
          </p:txBody>
        </p:sp>
        <p:sp>
          <p:nvSpPr>
            <p:cNvPr id="67" name="Textfeld 46"/>
            <p:cNvSpPr txBox="1">
              <a:spLocks noChangeArrowheads="1"/>
            </p:cNvSpPr>
            <p:nvPr/>
          </p:nvSpPr>
          <p:spPr bwMode="auto">
            <a:xfrm rot="16200000">
              <a:off x="2088272" y="5026900"/>
              <a:ext cx="338554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lnSpc>
                  <a:spcPct val="100000"/>
                </a:lnSpc>
                <a:spcBef>
                  <a:spcPct val="0"/>
                </a:spcBef>
                <a:buFontTx/>
                <a:buNone/>
              </a:pPr>
              <a:r>
                <a:rPr lang="de-DE" altLang="de-DE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72h</a:t>
              </a:r>
            </a:p>
          </p:txBody>
        </p:sp>
      </p:grpSp>
      <p:sp>
        <p:nvSpPr>
          <p:cNvPr id="68" name="Rectangle 67"/>
          <p:cNvSpPr/>
          <p:nvPr/>
        </p:nvSpPr>
        <p:spPr>
          <a:xfrm>
            <a:off x="204292" y="51849"/>
            <a:ext cx="810478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igure 1</a:t>
            </a:r>
            <a:endParaRPr lang="de-DE" sz="1500" dirty="0"/>
          </a:p>
        </p:txBody>
      </p:sp>
      <p:sp>
        <p:nvSpPr>
          <p:cNvPr id="70" name="Textfeld 19"/>
          <p:cNvSpPr txBox="1">
            <a:spLocks noChangeArrowheads="1"/>
          </p:cNvSpPr>
          <p:nvPr/>
        </p:nvSpPr>
        <p:spPr bwMode="auto">
          <a:xfrm>
            <a:off x="299719" y="899269"/>
            <a:ext cx="62978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8S rRNA</a:t>
            </a:r>
          </a:p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S rRNA</a:t>
            </a:r>
            <a:endParaRPr lang="de-DE" alt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Picture 7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513" y="529367"/>
            <a:ext cx="1345784" cy="1111527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907350" y="3876882"/>
            <a:ext cx="1274712" cy="611042"/>
          </a:xfrm>
          <a:prstGeom prst="rect">
            <a:avLst/>
          </a:prstGeom>
        </p:spPr>
      </p:pic>
      <p:pic>
        <p:nvPicPr>
          <p:cNvPr id="74" name="Picture 7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7351" y="3169207"/>
            <a:ext cx="1274712" cy="553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7199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183026" y="347669"/>
            <a:ext cx="29527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/>
              <a:t>A</a:t>
            </a:r>
            <a:endParaRPr lang="de-DE" sz="1500" dirty="0"/>
          </a:p>
        </p:txBody>
      </p:sp>
      <p:sp>
        <p:nvSpPr>
          <p:cNvPr id="28" name="Textfeld 19"/>
          <p:cNvSpPr txBox="1">
            <a:spLocks noChangeArrowheads="1"/>
          </p:cNvSpPr>
          <p:nvPr/>
        </p:nvSpPr>
        <p:spPr bwMode="auto">
          <a:xfrm>
            <a:off x="5887027" y="225739"/>
            <a:ext cx="674642" cy="302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29" name="Textfeld 19"/>
          <p:cNvSpPr txBox="1">
            <a:spLocks noChangeArrowheads="1"/>
          </p:cNvSpPr>
          <p:nvPr/>
        </p:nvSpPr>
        <p:spPr bwMode="auto">
          <a:xfrm>
            <a:off x="5871018" y="732935"/>
            <a:ext cx="674642" cy="302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0" name="Textfeld 19"/>
          <p:cNvSpPr txBox="1">
            <a:spLocks noChangeArrowheads="1"/>
          </p:cNvSpPr>
          <p:nvPr/>
        </p:nvSpPr>
        <p:spPr bwMode="auto">
          <a:xfrm>
            <a:off x="3318798" y="649778"/>
            <a:ext cx="942785" cy="297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CX-5461</a:t>
            </a:r>
          </a:p>
        </p:txBody>
      </p:sp>
      <p:sp>
        <p:nvSpPr>
          <p:cNvPr id="31" name="Textfeld 19"/>
          <p:cNvSpPr txBox="1">
            <a:spLocks noChangeArrowheads="1"/>
          </p:cNvSpPr>
          <p:nvPr/>
        </p:nvSpPr>
        <p:spPr bwMode="auto">
          <a:xfrm>
            <a:off x="3143610" y="3449117"/>
            <a:ext cx="1152952" cy="2985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CX-5461 + UVC</a:t>
            </a:r>
          </a:p>
        </p:txBody>
      </p:sp>
      <p:sp>
        <p:nvSpPr>
          <p:cNvPr id="32" name="Textfeld 19"/>
          <p:cNvSpPr txBox="1">
            <a:spLocks noChangeArrowheads="1"/>
          </p:cNvSpPr>
          <p:nvPr/>
        </p:nvSpPr>
        <p:spPr bwMode="auto">
          <a:xfrm>
            <a:off x="3649894" y="2025602"/>
            <a:ext cx="611689" cy="297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UVC</a:t>
            </a:r>
          </a:p>
        </p:txBody>
      </p:sp>
      <p:sp>
        <p:nvSpPr>
          <p:cNvPr id="33" name="Textfeld 19"/>
          <p:cNvSpPr txBox="1">
            <a:spLocks noChangeArrowheads="1"/>
          </p:cNvSpPr>
          <p:nvPr/>
        </p:nvSpPr>
        <p:spPr bwMode="auto">
          <a:xfrm>
            <a:off x="5911733" y="1676420"/>
            <a:ext cx="674642" cy="302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34" name="Textfeld 19"/>
          <p:cNvSpPr txBox="1">
            <a:spLocks noChangeArrowheads="1"/>
          </p:cNvSpPr>
          <p:nvPr/>
        </p:nvSpPr>
        <p:spPr bwMode="auto">
          <a:xfrm>
            <a:off x="5911733" y="2125603"/>
            <a:ext cx="674642" cy="302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5" name="Textfeld 19"/>
          <p:cNvSpPr txBox="1">
            <a:spLocks noChangeArrowheads="1"/>
          </p:cNvSpPr>
          <p:nvPr/>
        </p:nvSpPr>
        <p:spPr bwMode="auto">
          <a:xfrm>
            <a:off x="5952439" y="2962826"/>
            <a:ext cx="674642" cy="302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880632" y="4495668"/>
            <a:ext cx="28725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/>
              <a:t>C</a:t>
            </a:r>
            <a:endParaRPr lang="de-DE" sz="1500" dirty="0"/>
          </a:p>
        </p:txBody>
      </p:sp>
      <p:sp>
        <p:nvSpPr>
          <p:cNvPr id="37" name="TextBox 36"/>
          <p:cNvSpPr txBox="1"/>
          <p:nvPr/>
        </p:nvSpPr>
        <p:spPr>
          <a:xfrm>
            <a:off x="421109" y="1109820"/>
            <a:ext cx="503664" cy="20005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7668" y="2624863"/>
            <a:ext cx="917238" cy="20005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shRNA TIF-IA 8-2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1351" y="3763800"/>
            <a:ext cx="917238" cy="20005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shRNA TIF-IA 8-5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-13109" y="5204805"/>
            <a:ext cx="966931" cy="20005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shRNA TIF-IA 8-11</a:t>
            </a:r>
          </a:p>
        </p:txBody>
      </p:sp>
      <p:sp>
        <p:nvSpPr>
          <p:cNvPr id="41" name="Textfeld 19"/>
          <p:cNvSpPr txBox="1">
            <a:spLocks noChangeArrowheads="1"/>
          </p:cNvSpPr>
          <p:nvPr/>
        </p:nvSpPr>
        <p:spPr bwMode="auto">
          <a:xfrm>
            <a:off x="2783661" y="965477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42" name="Textfeld 19"/>
          <p:cNvSpPr txBox="1">
            <a:spLocks noChangeArrowheads="1"/>
          </p:cNvSpPr>
          <p:nvPr/>
        </p:nvSpPr>
        <p:spPr bwMode="auto">
          <a:xfrm>
            <a:off x="2783661" y="1753629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3" name="Textfeld 19"/>
          <p:cNvSpPr txBox="1">
            <a:spLocks noChangeArrowheads="1"/>
          </p:cNvSpPr>
          <p:nvPr/>
        </p:nvSpPr>
        <p:spPr bwMode="auto">
          <a:xfrm>
            <a:off x="2783661" y="2469500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44" name="Textfeld 19"/>
          <p:cNvSpPr txBox="1">
            <a:spLocks noChangeArrowheads="1"/>
          </p:cNvSpPr>
          <p:nvPr/>
        </p:nvSpPr>
        <p:spPr bwMode="auto">
          <a:xfrm>
            <a:off x="2783661" y="2810929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5" name="Textfeld 19"/>
          <p:cNvSpPr txBox="1">
            <a:spLocks noChangeArrowheads="1"/>
          </p:cNvSpPr>
          <p:nvPr/>
        </p:nvSpPr>
        <p:spPr bwMode="auto">
          <a:xfrm>
            <a:off x="2783661" y="3560480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46" name="Textfeld 19"/>
          <p:cNvSpPr txBox="1">
            <a:spLocks noChangeArrowheads="1"/>
          </p:cNvSpPr>
          <p:nvPr/>
        </p:nvSpPr>
        <p:spPr bwMode="auto">
          <a:xfrm>
            <a:off x="2783661" y="4088438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7" name="Textfeld 19"/>
          <p:cNvSpPr txBox="1">
            <a:spLocks noChangeArrowheads="1"/>
          </p:cNvSpPr>
          <p:nvPr/>
        </p:nvSpPr>
        <p:spPr bwMode="auto">
          <a:xfrm>
            <a:off x="2783661" y="5055038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48" name="Textfeld 19"/>
          <p:cNvSpPr txBox="1">
            <a:spLocks noChangeArrowheads="1"/>
          </p:cNvSpPr>
          <p:nvPr/>
        </p:nvSpPr>
        <p:spPr bwMode="auto">
          <a:xfrm>
            <a:off x="2783661" y="5353062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519361" y="-26442"/>
            <a:ext cx="28886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/>
              <a:t>B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65877" y="6360663"/>
            <a:ext cx="30328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smtClean="0"/>
              <a:t>D</a:t>
            </a:r>
            <a:endParaRPr lang="de-DE" sz="1500" dirty="0"/>
          </a:p>
        </p:txBody>
      </p:sp>
      <p:sp>
        <p:nvSpPr>
          <p:cNvPr id="76" name="Rectangle 75"/>
          <p:cNvSpPr/>
          <p:nvPr/>
        </p:nvSpPr>
        <p:spPr>
          <a:xfrm>
            <a:off x="204292" y="51849"/>
            <a:ext cx="810478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igure 3</a:t>
            </a:r>
            <a:endParaRPr lang="de-DE" sz="1500" dirty="0"/>
          </a:p>
        </p:txBody>
      </p:sp>
      <p:sp>
        <p:nvSpPr>
          <p:cNvPr id="77" name="Textfeld 19"/>
          <p:cNvSpPr txBox="1">
            <a:spLocks noChangeArrowheads="1"/>
          </p:cNvSpPr>
          <p:nvPr/>
        </p:nvSpPr>
        <p:spPr bwMode="auto">
          <a:xfrm>
            <a:off x="6028693" y="4971229"/>
            <a:ext cx="437940" cy="199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pic>
        <p:nvPicPr>
          <p:cNvPr id="78" name="Picture 7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01858" y="20740"/>
            <a:ext cx="1544409" cy="704790"/>
          </a:xfrm>
          <a:prstGeom prst="rect">
            <a:avLst/>
          </a:prstGeom>
        </p:spPr>
      </p:pic>
      <p:pic>
        <p:nvPicPr>
          <p:cNvPr id="79" name="Picture 7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96562" y="763026"/>
            <a:ext cx="1574456" cy="522682"/>
          </a:xfrm>
          <a:prstGeom prst="rect">
            <a:avLst/>
          </a:prstGeom>
        </p:spPr>
      </p:pic>
      <p:pic>
        <p:nvPicPr>
          <p:cNvPr id="80" name="Picture 7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61583" y="1534699"/>
            <a:ext cx="1650150" cy="542192"/>
          </a:xfrm>
          <a:prstGeom prst="rect">
            <a:avLst/>
          </a:prstGeom>
        </p:spPr>
      </p:pic>
      <p:pic>
        <p:nvPicPr>
          <p:cNvPr id="81" name="Picture 8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61584" y="2184004"/>
            <a:ext cx="1650150" cy="482708"/>
          </a:xfrm>
          <a:prstGeom prst="rect">
            <a:avLst/>
          </a:prstGeom>
        </p:spPr>
      </p:pic>
      <p:pic>
        <p:nvPicPr>
          <p:cNvPr id="82" name="Picture 8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61583" y="2762772"/>
            <a:ext cx="1650150" cy="741442"/>
          </a:xfrm>
          <a:prstGeom prst="rect">
            <a:avLst/>
          </a:prstGeom>
        </p:spPr>
      </p:pic>
      <p:pic>
        <p:nvPicPr>
          <p:cNvPr id="83" name="Picture 8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61584" y="3544059"/>
            <a:ext cx="1650149" cy="738540"/>
          </a:xfrm>
          <a:prstGeom prst="rect">
            <a:avLst/>
          </a:prstGeom>
        </p:spPr>
      </p:pic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8"/>
          <a:srcRect t="24665" b="36461"/>
          <a:stretch/>
        </p:blipFill>
        <p:spPr>
          <a:xfrm>
            <a:off x="4263554" y="4743140"/>
            <a:ext cx="1767595" cy="681653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61583" y="5458651"/>
            <a:ext cx="2100874" cy="829049"/>
          </a:xfrm>
          <a:prstGeom prst="rect">
            <a:avLst/>
          </a:prstGeom>
        </p:spPr>
      </p:pic>
      <p:pic>
        <p:nvPicPr>
          <p:cNvPr id="86" name="Picture 8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61583" y="6281034"/>
            <a:ext cx="2062392" cy="662912"/>
          </a:xfrm>
          <a:prstGeom prst="rect">
            <a:avLst/>
          </a:prstGeom>
        </p:spPr>
      </p:pic>
      <p:sp>
        <p:nvSpPr>
          <p:cNvPr id="87" name="Textfeld 18"/>
          <p:cNvSpPr txBox="1">
            <a:spLocks noChangeArrowheads="1"/>
          </p:cNvSpPr>
          <p:nvPr/>
        </p:nvSpPr>
        <p:spPr bwMode="auto">
          <a:xfrm>
            <a:off x="6028693" y="5854779"/>
            <a:ext cx="437940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HDM2</a:t>
            </a:r>
          </a:p>
        </p:txBody>
      </p:sp>
      <p:sp>
        <p:nvSpPr>
          <p:cNvPr id="88" name="Textfeld 27"/>
          <p:cNvSpPr txBox="1">
            <a:spLocks noChangeArrowheads="1"/>
          </p:cNvSpPr>
          <p:nvPr/>
        </p:nvSpPr>
        <p:spPr bwMode="auto">
          <a:xfrm>
            <a:off x="6028693" y="6483773"/>
            <a:ext cx="494046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pic>
        <p:nvPicPr>
          <p:cNvPr id="89" name="Picture 8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1311" y="1184713"/>
            <a:ext cx="1869897" cy="818886"/>
          </a:xfrm>
          <a:prstGeom prst="rect">
            <a:avLst/>
          </a:prstGeom>
        </p:spPr>
      </p:pic>
      <p:pic>
        <p:nvPicPr>
          <p:cNvPr id="90" name="Picture 8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3822" y="5307586"/>
            <a:ext cx="1884133" cy="568579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698" y="2734540"/>
            <a:ext cx="1880257" cy="461308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503" y="3885319"/>
            <a:ext cx="1892470" cy="731594"/>
          </a:xfrm>
          <a:prstGeom prst="rect">
            <a:avLst/>
          </a:prstGeom>
        </p:spPr>
      </p:pic>
      <p:pic>
        <p:nvPicPr>
          <p:cNvPr id="93" name="Picture 92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503" y="4726141"/>
            <a:ext cx="1892470" cy="532448"/>
          </a:xfrm>
          <a:prstGeom prst="rect">
            <a:avLst/>
          </a:prstGeom>
        </p:spPr>
      </p:pic>
      <p:pic>
        <p:nvPicPr>
          <p:cNvPr id="94" name="Picture 9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698" y="3284903"/>
            <a:ext cx="1902275" cy="578925"/>
          </a:xfrm>
          <a:prstGeom prst="rect">
            <a:avLst/>
          </a:prstGeom>
        </p:spPr>
      </p:pic>
      <p:pic>
        <p:nvPicPr>
          <p:cNvPr id="95" name="Picture 9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589" y="2189380"/>
            <a:ext cx="1856930" cy="500474"/>
          </a:xfrm>
          <a:prstGeom prst="rect">
            <a:avLst/>
          </a:prstGeom>
        </p:spPr>
      </p:pic>
      <p:pic>
        <p:nvPicPr>
          <p:cNvPr id="96" name="Picture 95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7503" y="717145"/>
            <a:ext cx="1870452" cy="430339"/>
          </a:xfrm>
          <a:prstGeom prst="rect">
            <a:avLst/>
          </a:prstGeom>
        </p:spPr>
      </p:pic>
      <p:sp>
        <p:nvSpPr>
          <p:cNvPr id="97" name="Textfeld 19"/>
          <p:cNvSpPr txBox="1">
            <a:spLocks noChangeArrowheads="1"/>
          </p:cNvSpPr>
          <p:nvPr/>
        </p:nvSpPr>
        <p:spPr bwMode="auto">
          <a:xfrm>
            <a:off x="4043545" y="6994365"/>
            <a:ext cx="437940" cy="199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DM2</a:t>
            </a:r>
            <a:endParaRPr lang="de-DE" alt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8" name="Picture 97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5997" y="7355727"/>
            <a:ext cx="1288551" cy="597888"/>
          </a:xfrm>
          <a:prstGeom prst="rect">
            <a:avLst/>
          </a:prstGeom>
        </p:spPr>
      </p:pic>
      <p:sp>
        <p:nvSpPr>
          <p:cNvPr id="99" name="Textfeld 19"/>
          <p:cNvSpPr txBox="1">
            <a:spLocks noChangeArrowheads="1"/>
          </p:cNvSpPr>
          <p:nvPr/>
        </p:nvSpPr>
        <p:spPr bwMode="auto">
          <a:xfrm>
            <a:off x="4043545" y="7533690"/>
            <a:ext cx="437940" cy="1993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11</a:t>
            </a:r>
            <a:endParaRPr lang="de-DE" alt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125196" y="7994300"/>
            <a:ext cx="5501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IP / CoIP</a:t>
            </a:r>
          </a:p>
        </p:txBody>
      </p:sp>
      <p:pic>
        <p:nvPicPr>
          <p:cNvPr id="101" name="Picture 100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868" y="7355728"/>
            <a:ext cx="1208785" cy="637806"/>
          </a:xfrm>
          <a:prstGeom prst="rect">
            <a:avLst/>
          </a:prstGeom>
        </p:spPr>
      </p:pic>
      <p:pic>
        <p:nvPicPr>
          <p:cNvPr id="102" name="Picture 101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894" y="6833742"/>
            <a:ext cx="1254731" cy="450919"/>
          </a:xfrm>
          <a:prstGeom prst="rect">
            <a:avLst/>
          </a:prstGeom>
        </p:spPr>
      </p:pic>
      <p:sp>
        <p:nvSpPr>
          <p:cNvPr id="103" name="TextBox 102"/>
          <p:cNvSpPr txBox="1"/>
          <p:nvPr/>
        </p:nvSpPr>
        <p:spPr>
          <a:xfrm>
            <a:off x="554424" y="7993534"/>
            <a:ext cx="3978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ad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" name="Picture 103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5997" y="6837949"/>
            <a:ext cx="1365504" cy="573024"/>
          </a:xfrm>
          <a:prstGeom prst="rect">
            <a:avLst/>
          </a:prstGeom>
        </p:spPr>
      </p:pic>
      <p:sp>
        <p:nvSpPr>
          <p:cNvPr id="105" name="Textfeld 19"/>
          <p:cNvSpPr txBox="1">
            <a:spLocks noChangeArrowheads="1"/>
          </p:cNvSpPr>
          <p:nvPr/>
        </p:nvSpPr>
        <p:spPr bwMode="auto">
          <a:xfrm>
            <a:off x="5883914" y="3817226"/>
            <a:ext cx="674642" cy="302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106" name="Picture 105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4518" y="6943946"/>
            <a:ext cx="1124048" cy="414325"/>
          </a:xfrm>
          <a:prstGeom prst="rect">
            <a:avLst/>
          </a:prstGeom>
        </p:spPr>
      </p:pic>
      <p:sp>
        <p:nvSpPr>
          <p:cNvPr id="107" name="TextBox 106"/>
          <p:cNvSpPr txBox="1"/>
          <p:nvPr/>
        </p:nvSpPr>
        <p:spPr>
          <a:xfrm>
            <a:off x="1763667" y="8022391"/>
            <a:ext cx="3353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8" name="Picture 107"/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7911" y="7370291"/>
            <a:ext cx="1121664" cy="6400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88184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Rectangle 58"/>
          <p:cNvSpPr/>
          <p:nvPr/>
        </p:nvSpPr>
        <p:spPr>
          <a:xfrm>
            <a:off x="204292" y="51849"/>
            <a:ext cx="89864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igure S1</a:t>
            </a:r>
            <a:endParaRPr lang="de-DE" sz="1500" dirty="0"/>
          </a:p>
        </p:txBody>
      </p:sp>
      <p:sp>
        <p:nvSpPr>
          <p:cNvPr id="60" name="Rectangle 59"/>
          <p:cNvSpPr/>
          <p:nvPr/>
        </p:nvSpPr>
        <p:spPr>
          <a:xfrm>
            <a:off x="204291" y="470949"/>
            <a:ext cx="29527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A</a:t>
            </a:r>
            <a:endParaRPr lang="de-DE" sz="15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565" y="1783079"/>
            <a:ext cx="1609094" cy="95206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565" y="869184"/>
            <a:ext cx="1512115" cy="816576"/>
          </a:xfrm>
          <a:prstGeom prst="rect">
            <a:avLst/>
          </a:prstGeom>
        </p:spPr>
      </p:pic>
      <p:sp>
        <p:nvSpPr>
          <p:cNvPr id="63" name="Textfeld 19"/>
          <p:cNvSpPr txBox="1">
            <a:spLocks noChangeArrowheads="1"/>
          </p:cNvSpPr>
          <p:nvPr/>
        </p:nvSpPr>
        <p:spPr bwMode="auto">
          <a:xfrm>
            <a:off x="2108659" y="1843189"/>
            <a:ext cx="485087" cy="203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l-GR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altLang="de-DE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2107479" y="1154788"/>
            <a:ext cx="461986" cy="20005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PL13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2108659" y="1254815"/>
            <a:ext cx="461986" cy="20005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algn="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de-DE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PL11</a:t>
            </a:r>
            <a:endParaRPr lang="de-DE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4605" y="1504208"/>
            <a:ext cx="1327908" cy="67796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4605" y="865411"/>
            <a:ext cx="1327908" cy="541477"/>
          </a:xfrm>
          <a:prstGeom prst="rect">
            <a:avLst/>
          </a:prstGeom>
        </p:spPr>
      </p:pic>
      <p:sp>
        <p:nvSpPr>
          <p:cNvPr id="70" name="Textfeld 19"/>
          <p:cNvSpPr txBox="1">
            <a:spLocks noChangeArrowheads="1"/>
          </p:cNvSpPr>
          <p:nvPr/>
        </p:nvSpPr>
        <p:spPr bwMode="auto">
          <a:xfrm>
            <a:off x="4831593" y="1126828"/>
            <a:ext cx="439544" cy="181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580" b="1" dirty="0">
                <a:latin typeface="Arial" panose="020B0604020202020204" pitchFamily="34" charset="0"/>
                <a:cs typeface="Arial" panose="020B0604020202020204" pitchFamily="34" charset="0"/>
              </a:rPr>
              <a:t>TIF-IA</a:t>
            </a:r>
          </a:p>
        </p:txBody>
      </p:sp>
      <p:sp>
        <p:nvSpPr>
          <p:cNvPr id="71" name="Textfeld 27"/>
          <p:cNvSpPr txBox="1">
            <a:spLocks noChangeArrowheads="1"/>
          </p:cNvSpPr>
          <p:nvPr/>
        </p:nvSpPr>
        <p:spPr bwMode="auto">
          <a:xfrm>
            <a:off x="4831593" y="1744684"/>
            <a:ext cx="439544" cy="181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de-DE" altLang="de-DE" sz="580" b="1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</a:p>
        </p:txBody>
      </p:sp>
      <p:sp>
        <p:nvSpPr>
          <p:cNvPr id="72" name="Rectangle 71"/>
          <p:cNvSpPr/>
          <p:nvPr/>
        </p:nvSpPr>
        <p:spPr>
          <a:xfrm>
            <a:off x="3219331" y="470949"/>
            <a:ext cx="272832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</a:t>
            </a:r>
            <a:endParaRPr lang="de-DE" sz="1500" dirty="0"/>
          </a:p>
        </p:txBody>
      </p:sp>
    </p:spTree>
    <p:extLst>
      <p:ext uri="{BB962C8B-B14F-4D97-AF65-F5344CB8AC3E}">
        <p14:creationId xmlns:p14="http://schemas.microsoft.com/office/powerpoint/2010/main" val="30756444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4491797"/>
              </p:ext>
            </p:extLst>
          </p:nvPr>
        </p:nvGraphicFramePr>
        <p:xfrm>
          <a:off x="611063" y="527604"/>
          <a:ext cx="3048000" cy="441007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09600"/>
                <a:gridCol w="609600"/>
                <a:gridCol w="609600"/>
                <a:gridCol w="609600"/>
                <a:gridCol w="609600"/>
              </a:tblGrid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8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1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6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4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6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4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78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4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578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8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71450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17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17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6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06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09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9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8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66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9550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6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5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39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1907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357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5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8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1907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381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21907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d change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8097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6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74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78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4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59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948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429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58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689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09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76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01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257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58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727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39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319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512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13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81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445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83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651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17" name="Rectangle 16"/>
          <p:cNvSpPr/>
          <p:nvPr/>
        </p:nvSpPr>
        <p:spPr>
          <a:xfrm>
            <a:off x="204292" y="51849"/>
            <a:ext cx="810478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igure 1</a:t>
            </a:r>
            <a:endParaRPr lang="de-DE" sz="1500" dirty="0"/>
          </a:p>
        </p:txBody>
      </p:sp>
    </p:spTree>
    <p:extLst>
      <p:ext uri="{BB962C8B-B14F-4D97-AF65-F5344CB8AC3E}">
        <p14:creationId xmlns:p14="http://schemas.microsoft.com/office/powerpoint/2010/main" val="33851919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8292778"/>
              </p:ext>
            </p:extLst>
          </p:nvPr>
        </p:nvGraphicFramePr>
        <p:xfrm>
          <a:off x="142899" y="339766"/>
          <a:ext cx="6155160" cy="7869786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1642"/>
                <a:gridCol w="352000"/>
                <a:gridCol w="383567"/>
                <a:gridCol w="302403"/>
                <a:gridCol w="302403"/>
                <a:gridCol w="302403"/>
                <a:gridCol w="409503"/>
                <a:gridCol w="302403"/>
                <a:gridCol w="302403"/>
                <a:gridCol w="302403"/>
                <a:gridCol w="302403"/>
                <a:gridCol w="302403"/>
                <a:gridCol w="302403"/>
                <a:gridCol w="302403"/>
                <a:gridCol w="302403"/>
                <a:gridCol w="302403"/>
                <a:gridCol w="302403"/>
                <a:gridCol w="302403"/>
                <a:gridCol w="302403"/>
                <a:gridCol w="302403"/>
              </a:tblGrid>
              <a:tr h="156642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A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B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79839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Time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FF95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CS3BE (CSA)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CS1AN (CSB)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Tim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UVC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Actinomycin D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Actinomycin D+UVC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0.6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6.8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9.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1.4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4.3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9.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4.5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3.0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3.8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5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4.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14.3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1.2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9.7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2.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5.3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1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1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7.6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5.2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8.7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5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3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69.3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58.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8.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39.9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.2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4.6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5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6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4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8.5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1.4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4.2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0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9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1.6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7.3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4.1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56642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C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D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Tim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UVC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Actinomycin D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Actinomycin D+UVC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Time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FF95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CS3BE (CSA)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b"/>
                      <a:r>
                        <a:rPr lang="de-DE" sz="700" u="none" strike="noStrike">
                          <a:effectLst/>
                        </a:rPr>
                        <a:t>CS1AN (CSB)</a:t>
                      </a:r>
                      <a:endParaRPr lang="de-DE" sz="7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.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.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5.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.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9.9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5.1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3.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1.2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3.6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0.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5.2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5.2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0.7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.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.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1.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3.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7.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0.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 dirty="0">
                          <a:effectLst/>
                        </a:rPr>
                        <a:t>48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4.4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4.7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7.2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89.5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5.9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96.8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6.8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59.0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1.5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4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.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.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1.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2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3.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4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08.6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 dirty="0">
                          <a:effectLst/>
                        </a:rPr>
                        <a:t>124.31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127.0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5.6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1.5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8.8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57.6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62.1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53.8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.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0.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6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29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31.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rtl="0" fontAlgn="b"/>
                      <a:r>
                        <a:rPr lang="de-DE" sz="700" u="none" strike="noStrike">
                          <a:effectLst/>
                        </a:rPr>
                        <a:t>35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71277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56642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E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15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shRNA 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344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1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9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413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993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975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797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649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673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5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4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.2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2.7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3.5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4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6.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9.0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6.0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8.300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93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8.031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.70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8.983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3.063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9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0.2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1.6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4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7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6.6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48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1.0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9.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0.6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.53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831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1.04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14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950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9.328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4.6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2.8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8.4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1.9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0.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3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72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0.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5.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3.7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8.04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396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2.425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2.20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8.318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7.879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7.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1.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6.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9.8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8.1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15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shRNA 8_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9.2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6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2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.654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.978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04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 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3.8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6.2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2.8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4.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4.3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4.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4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3.1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1.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0.6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6.356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997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6.99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1.184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1.648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0.413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1.4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4.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5.9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5.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5.8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5.6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48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6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6.4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6.991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7.399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9.253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7.269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5.393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6.474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2.7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2.5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6.6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6.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5.7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2.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72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5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2.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0.4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870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3.639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0.618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0.402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9.449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8.584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0.9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1.9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5.7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5.2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5.4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5.0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15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shRNA 8_1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344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4.9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7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8.5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943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096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716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6.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9.4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6.0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6.0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4.9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4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5.8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1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0.1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6.87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2.471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9.907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1.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5.7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7.4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1.0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1.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9.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48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1.1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4.3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2.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2.621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7.299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4.639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2.9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4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4.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2.9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5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72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6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8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5.347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2.780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4.866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4.1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6.3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2.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5.9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3.6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7.4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56642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F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UVC [10J/m</a:t>
                      </a:r>
                      <a:r>
                        <a:rPr lang="de-DE" sz="700" u="none" strike="noStrike" baseline="30000">
                          <a:effectLst/>
                        </a:rPr>
                        <a:t>2</a:t>
                      </a:r>
                      <a:r>
                        <a:rPr lang="de-DE" sz="700" u="none" strike="noStrike">
                          <a:effectLst/>
                        </a:rPr>
                        <a:t>]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150nM CX-546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150nM CX-5461 + 10J/m</a:t>
                      </a:r>
                      <a:r>
                        <a:rPr lang="de-DE" sz="700" u="none" strike="noStrike" baseline="30000">
                          <a:effectLst/>
                        </a:rPr>
                        <a:t>2</a:t>
                      </a:r>
                      <a:r>
                        <a:rPr lang="de-DE" sz="700" u="none" strike="noStrike">
                          <a:effectLst/>
                        </a:rPr>
                        <a:t> UVC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344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18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54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43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18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54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43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18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54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43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4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18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540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43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6.288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.93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7.982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8.369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903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.867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48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4.64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7.1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675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9.165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0.116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9.255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098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6.1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423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72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1.366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7.629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3.593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5.309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1.013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4.24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0.618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3.016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5.858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56642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G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H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I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14558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Mea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SD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Mea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SD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Mea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SD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N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82604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 (pUC)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1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 (pUC)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 (pUC)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4.0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.0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  <a:tr h="217602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 dirty="0">
                          <a:effectLst/>
                        </a:rPr>
                        <a:t>pTIF-IA</a:t>
                      </a:r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83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27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pTIF-IA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45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15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pTIF-IA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45.8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.7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242" marR="4242" marT="4242" marB="0" anchor="b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04292" y="51849"/>
            <a:ext cx="810478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igure 2</a:t>
            </a:r>
            <a:endParaRPr lang="de-DE" sz="1500" dirty="0"/>
          </a:p>
        </p:txBody>
      </p:sp>
    </p:spTree>
    <p:extLst>
      <p:ext uri="{BB962C8B-B14F-4D97-AF65-F5344CB8AC3E}">
        <p14:creationId xmlns:p14="http://schemas.microsoft.com/office/powerpoint/2010/main" val="3927436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7528177"/>
              </p:ext>
            </p:extLst>
          </p:nvPr>
        </p:nvGraphicFramePr>
        <p:xfrm>
          <a:off x="173721" y="611794"/>
          <a:ext cx="5526083" cy="390268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56937"/>
                <a:gridCol w="456937"/>
                <a:gridCol w="456937"/>
                <a:gridCol w="456937"/>
                <a:gridCol w="456937"/>
                <a:gridCol w="456937"/>
                <a:gridCol w="456937"/>
                <a:gridCol w="456937"/>
                <a:gridCol w="956713"/>
                <a:gridCol w="456937"/>
                <a:gridCol w="456937"/>
              </a:tblGrid>
              <a:tr h="14267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A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Fold chang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B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Fold chang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9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0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788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15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0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79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29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1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38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61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1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5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20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3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835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158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3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1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89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6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92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1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6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65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49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12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45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20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12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65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68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4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94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94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4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125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01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C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Fold chang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D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Mean (fold change)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Error+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Error-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8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9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5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5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150nM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37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44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42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47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300nm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43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39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33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3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47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1000nM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24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29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2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5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64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0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8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55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14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55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1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1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26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49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39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3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38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5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0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0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50h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50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3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026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E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700" u="none" strike="noStrike">
                          <a:effectLst/>
                        </a:rPr>
                        <a:t>Fold change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u="none" strike="noStrike">
                          <a:effectLst/>
                        </a:rPr>
                        <a:t>Control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.0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98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2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19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224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297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34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  <a:tr h="142670"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1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175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u="none" strike="noStrike">
                          <a:effectLst/>
                        </a:rPr>
                        <a:t>0.201</a:t>
                      </a:r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de-D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134" marR="7134" marT="7134" marB="0" anchor="b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204292" y="51849"/>
            <a:ext cx="89864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500" dirty="0" smtClean="0"/>
              <a:t>Figure S1</a:t>
            </a:r>
            <a:endParaRPr lang="de-DE" sz="1500" dirty="0"/>
          </a:p>
        </p:txBody>
      </p:sp>
    </p:spTree>
    <p:extLst>
      <p:ext uri="{BB962C8B-B14F-4D97-AF65-F5344CB8AC3E}">
        <p14:creationId xmlns:p14="http://schemas.microsoft.com/office/powerpoint/2010/main" val="29792798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06</Words>
  <Application>Microsoft Office PowerPoint</Application>
  <PresentationFormat>Custom</PresentationFormat>
  <Paragraphs>724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MS PGothic</vt:lpstr>
      <vt:lpstr>Arial</vt:lpstr>
      <vt:lpstr>Calibri</vt:lpstr>
      <vt:lpstr>Calibri Light</vt:lpstr>
      <vt:lpstr>Office Theme</vt:lpstr>
      <vt:lpstr>Prism 6</vt:lpstr>
      <vt:lpstr>GraphPad Prism 6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SK</dc:creator>
  <cp:lastModifiedBy>Marius Alupei</cp:lastModifiedBy>
  <cp:revision>81</cp:revision>
  <cp:lastPrinted>2017-05-23T07:30:53Z</cp:lastPrinted>
  <dcterms:created xsi:type="dcterms:W3CDTF">2015-07-06T12:59:17Z</dcterms:created>
  <dcterms:modified xsi:type="dcterms:W3CDTF">2017-05-26T08:42:05Z</dcterms:modified>
</cp:coreProperties>
</file>